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BE8C9A-C82D-4CB4-9EE8-D5121C9F16EA}" v="3" dt="2025-06-17T07:35:57.5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0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ya Engler" userId="1252e1b0b8bb23a8" providerId="LiveId" clId="{08BE8C9A-C82D-4CB4-9EE8-D5121C9F16EA}"/>
    <pc:docChg chg="custSel modSld">
      <pc:chgData name="Maya Engler" userId="1252e1b0b8bb23a8" providerId="LiveId" clId="{08BE8C9A-C82D-4CB4-9EE8-D5121C9F16EA}" dt="2025-06-17T07:38:30.371" v="86" actId="20577"/>
      <pc:docMkLst>
        <pc:docMk/>
      </pc:docMkLst>
      <pc:sldChg chg="addSp modSp mod">
        <pc:chgData name="Maya Engler" userId="1252e1b0b8bb23a8" providerId="LiveId" clId="{08BE8C9A-C82D-4CB4-9EE8-D5121C9F16EA}" dt="2025-06-17T07:38:30.371" v="86" actId="20577"/>
        <pc:sldMkLst>
          <pc:docMk/>
          <pc:sldMk cId="3627766220" sldId="256"/>
        </pc:sldMkLst>
        <pc:graphicFrameChg chg="add mod modGraphic">
          <ac:chgData name="Maya Engler" userId="1252e1b0b8bb23a8" providerId="LiveId" clId="{08BE8C9A-C82D-4CB4-9EE8-D5121C9F16EA}" dt="2025-06-17T07:36:17.039" v="80" actId="1076"/>
          <ac:graphicFrameMkLst>
            <pc:docMk/>
            <pc:sldMk cId="3627766220" sldId="256"/>
            <ac:graphicFrameMk id="2" creationId="{32EA4A8B-C8F8-048A-8B5E-940F1C6768F9}"/>
          </ac:graphicFrameMkLst>
        </pc:graphicFrameChg>
        <pc:graphicFrameChg chg="add mod">
          <ac:chgData name="Maya Engler" userId="1252e1b0b8bb23a8" providerId="LiveId" clId="{08BE8C9A-C82D-4CB4-9EE8-D5121C9F16EA}" dt="2025-06-17T07:36:09.643" v="79" actId="1076"/>
          <ac:graphicFrameMkLst>
            <pc:docMk/>
            <pc:sldMk cId="3627766220" sldId="256"/>
            <ac:graphicFrameMk id="3" creationId="{2DD154A4-53E7-43C3-8E5C-99AB7E46C93C}"/>
          </ac:graphicFrameMkLst>
        </pc:graphicFrameChg>
        <pc:graphicFrameChg chg="mod modGraphic">
          <ac:chgData name="Maya Engler" userId="1252e1b0b8bb23a8" providerId="LiveId" clId="{08BE8C9A-C82D-4CB4-9EE8-D5121C9F16EA}" dt="2025-06-17T07:38:30.371" v="86" actId="20577"/>
          <ac:graphicFrameMkLst>
            <pc:docMk/>
            <pc:sldMk cId="3627766220" sldId="256"/>
            <ac:graphicFrameMk id="4" creationId="{FC1180E8-8119-5DF1-FFAE-48CD84F07C48}"/>
          </ac:graphicFrameMkLst>
        </pc:graphicFrameChg>
        <pc:graphicFrameChg chg="mod">
          <ac:chgData name="Maya Engler" userId="1252e1b0b8bb23a8" providerId="LiveId" clId="{08BE8C9A-C82D-4CB4-9EE8-D5121C9F16EA}" dt="2025-06-17T07:35:51.038" v="75" actId="1076"/>
          <ac:graphicFrameMkLst>
            <pc:docMk/>
            <pc:sldMk cId="3627766220" sldId="256"/>
            <ac:graphicFrameMk id="5" creationId="{2E2FCDBC-0821-2553-35FF-E56CE3A2763A}"/>
          </ac:graphicFrameMkLst>
        </pc:graphicFrameChg>
        <pc:graphicFrameChg chg="mod">
          <ac:chgData name="Maya Engler" userId="1252e1b0b8bb23a8" providerId="LiveId" clId="{08BE8C9A-C82D-4CB4-9EE8-D5121C9F16EA}" dt="2025-06-09T11:02:41.617" v="38" actId="1035"/>
          <ac:graphicFrameMkLst>
            <pc:docMk/>
            <pc:sldMk cId="3627766220" sldId="256"/>
            <ac:graphicFrameMk id="6" creationId="{EFBEF841-BF65-90F6-2576-50EC9BB9FECE}"/>
          </ac:graphicFrameMkLst>
        </pc:graphicFrameChg>
        <pc:graphicFrameChg chg="add mod">
          <ac:chgData name="Maya Engler" userId="1252e1b0b8bb23a8" providerId="LiveId" clId="{08BE8C9A-C82D-4CB4-9EE8-D5121C9F16EA}" dt="2025-06-17T07:36:17.039" v="80" actId="1076"/>
          <ac:graphicFrameMkLst>
            <pc:docMk/>
            <pc:sldMk cId="3627766220" sldId="256"/>
            <ac:graphicFrameMk id="7" creationId="{599FBBF7-F941-BCB5-2086-7AE45EC178F8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D8A0EF64-70E9-9A64-4E70-0DFDEB716F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CD4D85C5-6484-ED20-30D6-7E1565AEBD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E626054F-8968-72E8-8735-D2FF5938D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1C9A5C1D-B0BB-2395-6E6A-F02E7367A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EB4B6A86-C735-4B2A-CC05-6D5A70A26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6727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5A07E3F-1785-9C7B-8F02-646865B58E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E3791A8B-7740-A5B0-06C3-6F520EE14E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F677BBDC-0675-4A56-57A1-E29044B46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42098A3-9D83-59BD-C71E-477BA9717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65F17330-588F-AE15-FB9E-608BEDEC0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59645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A9B189A1-6B17-E6F6-4DB1-A3C6A37CB6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AEC7B565-31F6-0F0F-0184-9B33B5C357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A94486B9-F4C8-0B16-B4A1-9B7BF61F5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ABD38FDA-7867-9385-4860-6FE62A4E4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25F1151B-2B00-565E-F393-347E0EE3D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42241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5A29281C-7BF5-1262-9B35-4050848F6E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1994828C-59EC-9B8A-65BC-A966DD1EF1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ACFA6404-7D1D-6885-79B7-69EC57A3D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676396A6-E5F3-3C26-9C39-0B2E7594E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C7BE2CD8-6C0F-B5B3-1EA3-2D804ABF1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64808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9343337A-5EB6-D627-1CCC-DCF320CEE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7685B7A8-B7BC-CE72-F0A8-86750618BE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E4F12441-4C8D-4995-7E40-ADE781F75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E7E11752-849F-C053-785C-3B1CAD491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AB376BDF-C510-60F5-9941-2DBAB29B9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35718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1A790616-F41F-543A-D4CB-1913BEEA35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762701F4-F3BE-607E-A78E-21935BD56F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4CB80A0C-36A0-7FE3-E753-1ADAB46D5B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FDF86B25-9985-BE9E-4BA5-BF9CF7CAB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CEF575E8-F02F-9518-9DF1-D56A6A6B9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C821A079-15B3-CF27-B4E8-BF02C3D6C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6833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9D46F11A-0058-CB20-C7F1-57F8C1A319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87F40981-9298-4640-22FC-08D7035A3A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CCABA119-F4ED-4E55-51D0-CD4DFEE355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190ED353-ADC0-2AB2-31D0-021A2BF540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5A1066D4-17EF-E396-F132-F178DABCDD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26C50784-5D39-1643-E641-8E0F5E3A6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2D4EAD43-6D86-724F-1F8F-D880ACD2E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9A10090C-FF5A-C116-35A4-6DDB1AD9B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16764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C549E6AE-9BFF-1A02-D7A9-24A96B4139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D999DF35-7A08-D5EE-377D-0133661CB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866F2ADF-76F7-85C3-2701-3E7BF7574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27431E7E-B128-F1B9-5356-681AC902D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3530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EF582034-5C1C-37D8-86F9-11412970E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5F48F79C-80F0-7E66-EB90-A36F551E7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F120206F-8FF8-FFBB-53A8-45939E13C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63187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4DB6AC62-A1C3-D0D8-DD8A-B0B1C8D3E5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A0AFD24A-0CFA-4079-B0A9-D0027041E5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6A532198-5524-CF23-94AB-CD180EF6AF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571E44C4-6984-1D31-5136-19D9BEA0B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D51C0AC9-0DBC-E0C0-C669-1D411C354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B86B5236-42D8-651C-AFE9-18C117854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84025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C03AE69-B1A7-153D-331B-B6F1229C4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BF30268A-CCB7-77A5-B980-F14CA72CAE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E7EF347D-1599-AF8C-C697-99FF02977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841F7FAD-84C4-9F27-8861-8D4554C23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07120A63-EA98-0666-FFDC-2FE899490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11FC9541-6B9C-007C-1253-855DEC310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4318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BA96791B-B960-DC5C-78FB-C72D91C5D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8973A5E1-E778-8DB6-7790-0A9C761E4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C86DD840-2FFA-2728-9BDB-E0684EEB3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CC2AE6-A16F-4BF0-B298-8506DE2917E7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2F4BF08-6C6D-EBEA-83C0-C1A3A12644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A4490A2-E591-3C84-47F9-B4AF380C8F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3CE287-AF6B-4BE2-B0A7-0118E80274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80584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C1180E8-8119-5DF1-FFAE-48CD84F07C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4817107"/>
              </p:ext>
            </p:extLst>
          </p:nvPr>
        </p:nvGraphicFramePr>
        <p:xfrm>
          <a:off x="532638" y="323007"/>
          <a:ext cx="5926074" cy="5461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38174">
                  <a:extLst>
                    <a:ext uri="{9D8B030D-6E8A-4147-A177-3AD203B41FA5}">
                      <a16:colId xmlns:a16="http://schemas.microsoft.com/office/drawing/2014/main" val="2722956652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452113924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662993597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91175049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745549334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015454539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00880624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16363355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881370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779852181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700984402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56326609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2135204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024255738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thor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2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3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4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5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6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7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8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9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0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2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 dirty="0">
                          <a:effectLst/>
                        </a:rPr>
                        <a:t>13</a:t>
                      </a:r>
                      <a:endParaRPr lang="he-IL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82384890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Michell et al. [46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563394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Bilsland et al. [48]</a:t>
                      </a:r>
                      <a:endParaRPr lang="en-US" sz="1100" b="0" i="0" u="none" strike="noStrike" dirty="0">
                        <a:solidFill>
                          <a:srgbClr val="EE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8405364"/>
                  </a:ext>
                </a:extLst>
              </a:tr>
            </a:tbl>
          </a:graphicData>
        </a:graphic>
      </p:graphicFrame>
      <p:graphicFrame>
        <p:nvGraphicFramePr>
          <p:cNvPr id="5" name="טבלה 4">
            <a:extLst>
              <a:ext uri="{FF2B5EF4-FFF2-40B4-BE49-F238E27FC236}">
                <a16:creationId xmlns:a16="http://schemas.microsoft.com/office/drawing/2014/main" id="{2E2FCDBC-0821-2553-35FF-E56CE3A276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0168147"/>
              </p:ext>
            </p:extLst>
          </p:nvPr>
        </p:nvGraphicFramePr>
        <p:xfrm>
          <a:off x="6620163" y="320421"/>
          <a:ext cx="1320800" cy="5524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02577004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5438820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204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8475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ncl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458592"/>
                  </a:ext>
                </a:extLst>
              </a:tr>
            </a:tbl>
          </a:graphicData>
        </a:graphic>
      </p:graphicFrame>
      <p:graphicFrame>
        <p:nvGraphicFramePr>
          <p:cNvPr id="6" name="טבלה 5">
            <a:extLst>
              <a:ext uri="{FF2B5EF4-FFF2-40B4-BE49-F238E27FC236}">
                <a16:creationId xmlns:a16="http://schemas.microsoft.com/office/drawing/2014/main" id="{EFBEF841-BF65-90F6-2576-50EC9BB9FE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929817"/>
              </p:ext>
            </p:extLst>
          </p:nvPr>
        </p:nvGraphicFramePr>
        <p:xfrm>
          <a:off x="532638" y="991408"/>
          <a:ext cx="10515599" cy="24257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0693">
                  <a:extLst>
                    <a:ext uri="{9D8B030D-6E8A-4147-A177-3AD203B41FA5}">
                      <a16:colId xmlns:a16="http://schemas.microsoft.com/office/drawing/2014/main" val="3073963437"/>
                    </a:ext>
                  </a:extLst>
                </a:gridCol>
                <a:gridCol w="9884906">
                  <a:extLst>
                    <a:ext uri="{9D8B030D-6E8A-4147-A177-3AD203B41FA5}">
                      <a16:colId xmlns:a16="http://schemas.microsoft.com/office/drawing/2014/main" val="2795792204"/>
                    </a:ext>
                  </a:extLst>
                </a:gridCol>
              </a:tblGrid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as true randomization used for assignment of participants to treatment group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489253220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as allocation to treatment groups conceal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44372409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treatment groups similar at the baseline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1402670545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participants blind to treatment assignment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4059598509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 dirty="0">
                          <a:effectLst/>
                        </a:rPr>
                        <a:t>Were those delivering treatment blind to treatment assignment?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347271641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outcomes assessors blind to treatment assignment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069919997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treatment groups treated identically other than the intervention of interest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085675240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as follow up complete and if not, were differences between groups in terms of their follow up adequately described and analyz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412803478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participants analyzed in the groups to which they were randomiz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335049697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outcomes measured in the same way for treatment group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802785602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ere outcomes measured in a reliable wa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792137279"/>
                  </a:ext>
                </a:extLst>
              </a:tr>
              <a:tr h="1698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>
                          <a:effectLst/>
                        </a:rPr>
                        <a:t>Was appropriate statistical analysis us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595153363"/>
                  </a:ext>
                </a:extLst>
              </a:tr>
              <a:tr h="3262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NZ" sz="1100" u="none" strike="noStrike" dirty="0">
                          <a:effectLst/>
                        </a:rPr>
                        <a:t>Was the trial design appropriate, and any deviations from the standard RCT design (individual randomization, parallel groups) accounted for in the conduct and analysis of the trial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4" marR="6064" marT="6064" marB="0" anchor="ctr"/>
                </a:tc>
                <a:extLst>
                  <a:ext uri="{0D108BD9-81ED-4DB2-BD59-A6C34878D82A}">
                    <a16:rowId xmlns:a16="http://schemas.microsoft.com/office/drawing/2014/main" val="3703817267"/>
                  </a:ext>
                </a:extLst>
              </a:tr>
            </a:tbl>
          </a:graphicData>
        </a:graphic>
      </p:graphicFrame>
      <p:graphicFrame>
        <p:nvGraphicFramePr>
          <p:cNvPr id="2" name="טבלה 1">
            <a:extLst>
              <a:ext uri="{FF2B5EF4-FFF2-40B4-BE49-F238E27FC236}">
                <a16:creationId xmlns:a16="http://schemas.microsoft.com/office/drawing/2014/main" id="{32EA4A8B-C8F8-048A-8B5E-940F1C6768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3864919"/>
              </p:ext>
            </p:extLst>
          </p:nvPr>
        </p:nvGraphicFramePr>
        <p:xfrm>
          <a:off x="532638" y="3946328"/>
          <a:ext cx="5169154" cy="361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17854">
                  <a:extLst>
                    <a:ext uri="{9D8B030D-6E8A-4147-A177-3AD203B41FA5}">
                      <a16:colId xmlns:a16="http://schemas.microsoft.com/office/drawing/2014/main" val="19179365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859629497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49242903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72515545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99586780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95007408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970759628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4206312339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688642506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15231755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79201842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504856504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tho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2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3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4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5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6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7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 dirty="0">
                          <a:effectLst/>
                        </a:rPr>
                        <a:t>8</a:t>
                      </a:r>
                      <a:endParaRPr lang="he-IL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9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0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0120722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</a:rPr>
                        <a:t>Pesqué</a:t>
                      </a:r>
                      <a:r>
                        <a:rPr lang="en-US" sz="1100" u="none" strike="noStrike" dirty="0">
                          <a:effectLst/>
                        </a:rPr>
                        <a:t> et al. [49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4617322"/>
                  </a:ext>
                </a:extLst>
              </a:tr>
            </a:tbl>
          </a:graphicData>
        </a:graphic>
      </p:graphicFrame>
      <p:graphicFrame>
        <p:nvGraphicFramePr>
          <p:cNvPr id="3" name="טבלה 2">
            <a:extLst>
              <a:ext uri="{FF2B5EF4-FFF2-40B4-BE49-F238E27FC236}">
                <a16:creationId xmlns:a16="http://schemas.microsoft.com/office/drawing/2014/main" id="{2DD154A4-53E7-43C3-8E5C-99AB7E46C9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4647090"/>
              </p:ext>
            </p:extLst>
          </p:nvPr>
        </p:nvGraphicFramePr>
        <p:xfrm>
          <a:off x="532638" y="4612362"/>
          <a:ext cx="7264400" cy="2025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2688323726"/>
                    </a:ext>
                  </a:extLst>
                </a:gridCol>
                <a:gridCol w="6604000">
                  <a:extLst>
                    <a:ext uri="{9D8B030D-6E8A-4147-A177-3AD203B41FA5}">
                      <a16:colId xmlns:a16="http://schemas.microsoft.com/office/drawing/2014/main" val="2177860295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the two groups similar and recruited from the same population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7250760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 dirty="0">
                          <a:effectLst/>
                        </a:rPr>
                        <a:t>Were the exposures measured similarly to assign people to both exposed and unexposed groups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2657165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the exposure measured in a valid and reliable wa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986028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confounding factors identifi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1913598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strategies to deal with confounding factors stat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114444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the groups/participants free of the outcome at the start of the study (or at the moment of exposure)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230617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the outcomes measured in a valid and reliable wa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4789207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the follow up time reported and sufficient to be long enough for outcomes to occur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294234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follow up complete, and if not, were the reasons to loss to follow up described and explor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4754724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strategies to address incomplete follow up utiliz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8449317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 dirty="0">
                          <a:effectLst/>
                        </a:rPr>
                        <a:t>Was appropriate statistical analysis used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18513623"/>
                  </a:ext>
                </a:extLst>
              </a:tr>
            </a:tbl>
          </a:graphicData>
        </a:graphic>
      </p:graphicFrame>
      <p:graphicFrame>
        <p:nvGraphicFramePr>
          <p:cNvPr id="7" name="טבלה 6">
            <a:extLst>
              <a:ext uri="{FF2B5EF4-FFF2-40B4-BE49-F238E27FC236}">
                <a16:creationId xmlns:a16="http://schemas.microsoft.com/office/drawing/2014/main" id="{599FBBF7-F941-BCB5-2086-7AE45EC178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3413802"/>
              </p:ext>
            </p:extLst>
          </p:nvPr>
        </p:nvGraphicFramePr>
        <p:xfrm>
          <a:off x="5829810" y="3946328"/>
          <a:ext cx="1320800" cy="5524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02577004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5438820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204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8475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ncl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4585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27766220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06</Words>
  <Application>Microsoft Office PowerPoint</Application>
  <PresentationFormat>מסך רחב</PresentationFormat>
  <Paragraphs>113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4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ערכת נושא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ya Engler</dc:creator>
  <cp:lastModifiedBy>Maya Engler</cp:lastModifiedBy>
  <cp:revision>1</cp:revision>
  <dcterms:created xsi:type="dcterms:W3CDTF">2025-06-09T10:58:21Z</dcterms:created>
  <dcterms:modified xsi:type="dcterms:W3CDTF">2025-06-17T07:38:36Z</dcterms:modified>
</cp:coreProperties>
</file>